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83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41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993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84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112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8117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559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730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320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415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364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CCC74B-55CB-44A5-82FC-B5963FBEA8B7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49C143-458B-45A1-BDBE-FAEEBE4968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780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54379D0-5DAE-850D-DF90-E948F82BBAA1}"/>
              </a:ext>
            </a:extLst>
          </p:cNvPr>
          <p:cNvSpPr txBox="1"/>
          <p:nvPr/>
        </p:nvSpPr>
        <p:spPr>
          <a:xfrm flipH="1">
            <a:off x="363675" y="212356"/>
            <a:ext cx="860325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</a:rPr>
              <a:t>Supplemental Figure 1. Kaplan-Meier analysis of recurrence-free survival after surgical treatment for pT3a clear cell renal cell carcinoma in patients divided in four groups according to number of white blood cells</a:t>
            </a:r>
            <a:endParaRPr lang="ja-JP" altLang="en-US" sz="1600" dirty="0"/>
          </a:p>
        </p:txBody>
      </p: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C8FBEF36-EE43-1C4C-E635-F2D9DE7E91BB}"/>
              </a:ext>
            </a:extLst>
          </p:cNvPr>
          <p:cNvGrpSpPr/>
          <p:nvPr/>
        </p:nvGrpSpPr>
        <p:grpSpPr>
          <a:xfrm>
            <a:off x="1091466" y="1226969"/>
            <a:ext cx="6673704" cy="5043011"/>
            <a:chOff x="1091466" y="1226969"/>
            <a:chExt cx="6673704" cy="5043011"/>
          </a:xfrm>
        </p:grpSpPr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AD8BC236-BE7D-162B-8463-EB33A1D07A1D}"/>
                </a:ext>
              </a:extLst>
            </p:cNvPr>
            <p:cNvSpPr/>
            <p:nvPr/>
          </p:nvSpPr>
          <p:spPr>
            <a:xfrm>
              <a:off x="1091466" y="1226969"/>
              <a:ext cx="6452378" cy="50430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23045CEC-3CE7-0C13-6FD4-9E936A2D9C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229" t="9943" r="5307" b="24840"/>
            <a:stretch/>
          </p:blipFill>
          <p:spPr>
            <a:xfrm>
              <a:off x="2407298" y="1226970"/>
              <a:ext cx="4683968" cy="3844213"/>
            </a:xfrm>
            <a:prstGeom prst="rect">
              <a:avLst/>
            </a:prstGeom>
          </p:spPr>
        </p:pic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E24F09AD-2630-8E66-E4B2-3078A5BB6F76}"/>
                </a:ext>
              </a:extLst>
            </p:cNvPr>
            <p:cNvSpPr txBox="1"/>
            <p:nvPr/>
          </p:nvSpPr>
          <p:spPr>
            <a:xfrm>
              <a:off x="2524953" y="5071183"/>
              <a:ext cx="4280701" cy="49629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      20           </a:t>
              </a:r>
              <a:r>
                <a:rPr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40             60              80            </a:t>
              </a:r>
            </a:p>
            <a:p>
              <a:pPr>
                <a:lnSpc>
                  <a:spcPts val="1200"/>
                </a:lnSpc>
              </a:pPr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                      </a:t>
              </a:r>
            </a:p>
            <a:p>
              <a:pPr>
                <a:lnSpc>
                  <a:spcPts val="535"/>
                </a:lnSpc>
              </a:pPr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      Months</a:t>
              </a:r>
            </a:p>
          </p:txBody>
        </p:sp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A821351B-BC50-7F10-DB33-1E034DE39C11}"/>
                </a:ext>
              </a:extLst>
            </p:cNvPr>
            <p:cNvGrpSpPr/>
            <p:nvPr/>
          </p:nvGrpSpPr>
          <p:grpSpPr>
            <a:xfrm>
              <a:off x="1976870" y="1422243"/>
              <a:ext cx="615756" cy="3739908"/>
              <a:chOff x="3857989" y="2027584"/>
              <a:chExt cx="494931" cy="1951716"/>
            </a:xfrm>
          </p:grpSpPr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DF1C1855-23F0-0A98-6012-89237EACBC79}"/>
                  </a:ext>
                </a:extLst>
              </p:cNvPr>
              <p:cNvSpPr txBox="1"/>
              <p:nvPr/>
            </p:nvSpPr>
            <p:spPr>
              <a:xfrm>
                <a:off x="3857989" y="2027584"/>
                <a:ext cx="473868" cy="26135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535"/>
                  </a:lnSpc>
                </a:pPr>
                <a:r>
                  <a:rPr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D9298D18-69FB-52C3-F0C6-5F7B5FF3E1AD}"/>
                  </a:ext>
                </a:extLst>
              </p:cNvPr>
              <p:cNvSpPr txBox="1"/>
              <p:nvPr/>
            </p:nvSpPr>
            <p:spPr>
              <a:xfrm>
                <a:off x="3924380" y="2369697"/>
                <a:ext cx="377740" cy="26135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535"/>
                  </a:lnSpc>
                </a:pPr>
                <a:r>
                  <a:rPr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35CBF921-1288-6CEA-F445-FE150082F995}"/>
                  </a:ext>
                </a:extLst>
              </p:cNvPr>
              <p:cNvSpPr txBox="1"/>
              <p:nvPr/>
            </p:nvSpPr>
            <p:spPr>
              <a:xfrm>
                <a:off x="3924380" y="2714734"/>
                <a:ext cx="377740" cy="26135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535"/>
                  </a:lnSpc>
                </a:pPr>
                <a:r>
                  <a:rPr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72139C79-F184-2A4B-EE5F-B2905E4264E1}"/>
                  </a:ext>
                </a:extLst>
              </p:cNvPr>
              <p:cNvSpPr txBox="1"/>
              <p:nvPr/>
            </p:nvSpPr>
            <p:spPr>
              <a:xfrm>
                <a:off x="3924380" y="3062644"/>
                <a:ext cx="377740" cy="26135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535"/>
                  </a:lnSpc>
                </a:pPr>
                <a:r>
                  <a:rPr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C28B7990-81D7-A485-09D2-747688D850EE}"/>
                  </a:ext>
                </a:extLst>
              </p:cNvPr>
              <p:cNvSpPr txBox="1"/>
              <p:nvPr/>
            </p:nvSpPr>
            <p:spPr>
              <a:xfrm>
                <a:off x="3924380" y="3431370"/>
                <a:ext cx="377740" cy="26135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535"/>
                  </a:lnSpc>
                </a:pPr>
                <a:r>
                  <a:rPr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9B399339-4215-3C6C-5BF2-0B02F30F16A4}"/>
                  </a:ext>
                </a:extLst>
              </p:cNvPr>
              <p:cNvSpPr txBox="1"/>
              <p:nvPr/>
            </p:nvSpPr>
            <p:spPr>
              <a:xfrm>
                <a:off x="3975180" y="3784282"/>
                <a:ext cx="377740" cy="19501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535"/>
                  </a:lnSpc>
                </a:pPr>
                <a:r>
                  <a:rPr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</p:grpSp>
        <p:sp>
          <p:nvSpPr>
            <p:cNvPr id="41" name="Rectangle 132">
              <a:extLst>
                <a:ext uri="{FF2B5EF4-FFF2-40B4-BE49-F238E27FC236}">
                  <a16:creationId xmlns:a16="http://schemas.microsoft.com/office/drawing/2014/main" id="{11372992-AE91-05C5-0B75-F20227844A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3745" y="2979800"/>
              <a:ext cx="3163623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>
              <a:spAutoFit/>
            </a:bodyPr>
            <a:lstStyle>
              <a:lvl1pPr algn="ctr"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 algn="ctr"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 algn="ctr"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 algn="ctr"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 algn="ctr"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algn="ctr" fontAlgn="base">
                <a:spcBef>
                  <a:spcPct val="0"/>
                </a:spcBef>
                <a:spcAft>
                  <a:spcPct val="0"/>
                </a:spcAft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algn="ctr" fontAlgn="base">
                <a:spcBef>
                  <a:spcPct val="0"/>
                </a:spcBef>
                <a:spcAft>
                  <a:spcPct val="0"/>
                </a:spcAft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algn="ctr" fontAlgn="base">
                <a:spcBef>
                  <a:spcPct val="0"/>
                </a:spcBef>
                <a:spcAft>
                  <a:spcPct val="0"/>
                </a:spcAft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algn="ctr" fontAlgn="base">
                <a:spcBef>
                  <a:spcPct val="0"/>
                </a:spcBef>
                <a:spcAft>
                  <a:spcPct val="0"/>
                </a:spcAft>
                <a:defRPr kumimoji="1" sz="1400" b="1">
                  <a:solidFill>
                    <a:schemeClr val="bg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1600" dirty="0">
                  <a:solidFill>
                    <a:srgbClr val="000000"/>
                  </a:solidFill>
                </a:rPr>
                <a:t>Recurrence-free survival rate (%)</a:t>
              </a: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49CF567B-AA31-1C6F-00BE-903691229B64}"/>
                </a:ext>
              </a:extLst>
            </p:cNvPr>
            <p:cNvSpPr txBox="1"/>
            <p:nvPr/>
          </p:nvSpPr>
          <p:spPr>
            <a:xfrm>
              <a:off x="1190652" y="5136240"/>
              <a:ext cx="12754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. at Risk</a:t>
              </a: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10A0721E-96BA-5DF2-CCF4-0ECCFA77298C}"/>
                </a:ext>
              </a:extLst>
            </p:cNvPr>
            <p:cNvSpPr txBox="1"/>
            <p:nvPr/>
          </p:nvSpPr>
          <p:spPr>
            <a:xfrm>
              <a:off x="1091466" y="5459502"/>
              <a:ext cx="6673704" cy="81047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1400"/>
                </a:lnSpc>
              </a:pP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6000		12                 9                   7                 3                  0          </a:t>
              </a:r>
            </a:p>
            <a:p>
              <a:pPr>
                <a:lnSpc>
                  <a:spcPts val="1400"/>
                </a:lnSpc>
              </a:pP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6000-8999	  	25               16                 10                 6                  4</a:t>
              </a:r>
            </a:p>
            <a:p>
              <a:pPr>
                <a:lnSpc>
                  <a:spcPts val="1400"/>
                </a:lnSpc>
              </a:pP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9000-15,000  	  4                 2                   1                 0                  0</a:t>
              </a:r>
            </a:p>
            <a:p>
              <a:pPr>
                <a:lnSpc>
                  <a:spcPts val="1400"/>
                </a:lnSpc>
              </a:pP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gt;15,000		  1                 0                   0                 0                  0      </a:t>
              </a:r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21112C49-8F98-C535-6C81-3F8ABF046524}"/>
                </a:ext>
              </a:extLst>
            </p:cNvPr>
            <p:cNvSpPr/>
            <p:nvPr/>
          </p:nvSpPr>
          <p:spPr>
            <a:xfrm>
              <a:off x="6475445" y="1226970"/>
              <a:ext cx="783771" cy="8104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7F473D2D-F959-BC53-8F0D-D3512E15A8F0}"/>
                </a:ext>
              </a:extLst>
            </p:cNvPr>
            <p:cNvCxnSpPr>
              <a:cxnSpLocks/>
            </p:cNvCxnSpPr>
            <p:nvPr/>
          </p:nvCxnSpPr>
          <p:spPr>
            <a:xfrm>
              <a:off x="6080611" y="3695643"/>
              <a:ext cx="159207" cy="0"/>
            </a:xfrm>
            <a:prstGeom prst="line">
              <a:avLst/>
            </a:prstGeom>
            <a:ln w="190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93C13EC2-74A8-799F-805A-0C379401C2D5}"/>
                </a:ext>
              </a:extLst>
            </p:cNvPr>
            <p:cNvCxnSpPr>
              <a:cxnSpLocks/>
            </p:cNvCxnSpPr>
            <p:nvPr/>
          </p:nvCxnSpPr>
          <p:spPr>
            <a:xfrm>
              <a:off x="6080611" y="4061004"/>
              <a:ext cx="15920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E74272D8-5B40-965F-3083-DD59302EC231}"/>
                </a:ext>
              </a:extLst>
            </p:cNvPr>
            <p:cNvCxnSpPr>
              <a:cxnSpLocks/>
            </p:cNvCxnSpPr>
            <p:nvPr/>
          </p:nvCxnSpPr>
          <p:spPr>
            <a:xfrm>
              <a:off x="6081985" y="4233772"/>
              <a:ext cx="15920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72BF602A-6E8F-9CE4-64E4-6D0B2D50C0F7}"/>
                </a:ext>
              </a:extLst>
            </p:cNvPr>
            <p:cNvCxnSpPr>
              <a:cxnSpLocks/>
            </p:cNvCxnSpPr>
            <p:nvPr/>
          </p:nvCxnSpPr>
          <p:spPr>
            <a:xfrm>
              <a:off x="6080611" y="3872953"/>
              <a:ext cx="159207" cy="0"/>
            </a:xfrm>
            <a:prstGeom prst="line">
              <a:avLst/>
            </a:prstGeom>
            <a:ln w="190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A735FAAB-18E1-0099-9304-DAC1F40B965C}"/>
                </a:ext>
              </a:extLst>
            </p:cNvPr>
            <p:cNvSpPr txBox="1"/>
            <p:nvPr/>
          </p:nvSpPr>
          <p:spPr>
            <a:xfrm>
              <a:off x="6231393" y="3561421"/>
              <a:ext cx="1375652" cy="81047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1400"/>
                </a:lnSpc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BC &lt;6000</a:t>
              </a:r>
            </a:p>
            <a:p>
              <a:pPr>
                <a:lnSpc>
                  <a:spcPts val="1400"/>
                </a:lnSpc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BC 6000-8999</a:t>
              </a:r>
            </a:p>
            <a:p>
              <a:pPr>
                <a:lnSpc>
                  <a:spcPts val="1400"/>
                </a:lnSpc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BC 9000-15,000</a:t>
              </a:r>
            </a:p>
            <a:p>
              <a:pPr>
                <a:lnSpc>
                  <a:spcPts val="1400"/>
                </a:lnSpc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BC &gt;15,000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4A3B5175-DA0F-39ED-4CDC-8CBD6A073A8C}"/>
                </a:ext>
              </a:extLst>
            </p:cNvPr>
            <p:cNvSpPr txBox="1"/>
            <p:nvPr/>
          </p:nvSpPr>
          <p:spPr>
            <a:xfrm flipH="1">
              <a:off x="2959853" y="4243672"/>
              <a:ext cx="120431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</a:rPr>
                <a:t>P&lt;0.0001</a:t>
              </a:r>
              <a:endParaRPr lang="ja-JP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893801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76</TotalTime>
  <Words>107</Words>
  <Application>Microsoft Macintosh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zom321@gmail.com</dc:creator>
  <cp:lastModifiedBy>Microsoft Office User</cp:lastModifiedBy>
  <cp:revision>134</cp:revision>
  <dcterms:created xsi:type="dcterms:W3CDTF">2023-05-06T00:40:49Z</dcterms:created>
  <dcterms:modified xsi:type="dcterms:W3CDTF">2025-09-26T10:01:56Z</dcterms:modified>
</cp:coreProperties>
</file>